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1" d="100"/>
          <a:sy n="81" d="100"/>
        </p:scale>
        <p:origin x="725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B6F86-E59B-498D-9D4B-BA10CC07A4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5919B2-E0A8-42EE-8000-601B4CDCB2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E189BB-8193-47E7-820A-86D1CE896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0A3905-4B1F-49AE-B8D8-B49745F7F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2CFE3C-83AD-4F59-9398-9BF93040A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535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6DF30B-3B6B-4E64-B4E2-3BCF2222BF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B32385-B89C-411C-9A4E-EAA6CC56D5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A34BAB-7897-4395-BAFE-16609CC9A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254F26-72EE-4A87-91B4-1CFD60C0F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334B59-A0DF-4131-BE7A-3AE221A62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21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F44CFF-5C5C-4782-92E9-72EED57CB5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70CE6E-2181-478A-8589-8FE0CE3CB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53EBC-C6DE-4000-B6C9-7BE9F23A5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30893-756A-4797-825D-B1AC47500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255E5B-5B65-40F6-922D-A87F18A7C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50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3E94A-8BB3-450D-AB00-B22C62C2C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827A2D-64C4-4350-AB71-160E3E4C74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FC1C0-801B-4280-A767-66A103C3A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9672D5-1D2A-43B7-BB53-201003E87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0A4E7C-E90B-46D2-8B52-11EFEE811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62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A5D3B-4AAD-40CF-ABE9-47E3E00F7D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97BC8-2BD0-47CF-962E-DFA690539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F7826-DFC7-45F7-83BA-492BBD8BC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6E593-8466-4FAE-A871-B5FE2F680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C77A69-EF5C-48BA-8CD5-DAA690080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675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2B939-9EE6-475A-B1C6-B7A6F92DB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709B4E-24FD-4793-BF76-4DC7005A30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948E18-FF47-455B-98B8-272B164F0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0895B6-1E04-40B3-BF82-487A1A040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F94FB8-1E92-4FA3-8FC3-4171D2312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660985-CF57-4A90-9860-4E7445AA0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482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F96CA2-C740-4E9B-A556-5ADEF4452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919ABE-B54D-4BA6-940B-6F41B6B70A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115960-2455-425B-B70C-7C8F20483C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56F2A0-CA32-4E8F-8EC7-F224649FED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907391-2F78-4242-B8BF-E51B41B6B9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12C9D8-DA34-43D8-A8FE-195A61E67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F2500B-D1CC-492A-B33F-6A5BE529F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E5B675-406F-41CB-B730-EA9B83F27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87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ACC93-9CFC-43D4-86DE-7423A8140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788462-D85C-4378-9707-E286D616B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BA981E-78DC-4B3A-929C-631C2735B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2DE450-89B7-46D4-9004-924D52FEE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070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0AB7A3-A817-4AC2-A2C7-1B9C0A24F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2756957-5E14-47EF-B5DA-A187BE681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180329-61BC-415C-9CBD-B27BB8357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128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95FEC-A4E5-48E3-A519-BABB897C17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4AC572-4A5D-4F6F-9E7E-00CADC3CF6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6F0457-642B-493A-A3CE-986239E8CC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F68A10-FEBD-40E9-9CAC-383E46C74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DEECE2-45A5-4960-95DC-C14EAB0C4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3A619E-A2F5-4AE7-A0D6-EE0EAFF5B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926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92DC1-7967-44ED-8213-375352EF3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8FB80F-461A-43EB-8707-D257E0086E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B39ABC-F1EB-4284-B693-36DA1755AA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F43689-27C0-4AF7-B9F6-212D676E5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924106-17CB-4DFC-8DC8-3A2411AAA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7675C-7A8D-41DD-8534-596890BEB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1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7E9C29-4D03-43DF-81F6-751BC66E9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03D461-1626-42AB-9CAF-392199C015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AB6239-E801-4089-8876-00A6CCFB7A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A276B-2F51-4B1B-871A-D28520C495CA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E2E074-67DB-4C96-A0C7-02D70E2AB1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50EC8-C483-42D3-BA66-2A21DE4F0E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908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B6519-796C-42B6-BA1B-6D0413AFB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88952" cy="914400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lcano plots showing the distribution of age-associated differentially methylated CpG positions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MP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 their effect size in M values and significance p value in the a)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African American (AA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b) white participants of the HANDLS study. </a:t>
            </a:r>
          </a:p>
        </p:txBody>
      </p:sp>
      <p:pic>
        <p:nvPicPr>
          <p:cNvPr id="7" name="Content Placeholder 9" descr="A close up of a map&#10;&#10;Description automatically generated">
            <a:extLst>
              <a:ext uri="{FF2B5EF4-FFF2-40B4-BE49-F238E27FC236}">
                <a16:creationId xmlns:a16="http://schemas.microsoft.com/office/drawing/2014/main" id="{4E5B6ABD-54C8-46F1-89CF-9C180F6CA02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593" y="1854724"/>
            <a:ext cx="4708688" cy="3383280"/>
          </a:xfrm>
        </p:spPr>
      </p:pic>
      <p:pic>
        <p:nvPicPr>
          <p:cNvPr id="8" name="Picture 7" descr="A close up of a map&#10;&#10;Description automatically generated">
            <a:extLst>
              <a:ext uri="{FF2B5EF4-FFF2-40B4-BE49-F238E27FC236}">
                <a16:creationId xmlns:a16="http://schemas.microsoft.com/office/drawing/2014/main" id="{17FF0C22-1D33-4FDF-97E5-392A3278DC0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8894" y="1854724"/>
            <a:ext cx="5243208" cy="338328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D295F9A-4C7F-4259-B2BC-DB578FE263B0}"/>
              </a:ext>
            </a:extLst>
          </p:cNvPr>
          <p:cNvSpPr/>
          <p:nvPr/>
        </p:nvSpPr>
        <p:spPr>
          <a:xfrm>
            <a:off x="199351" y="1199896"/>
            <a:ext cx="4219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CF8EB8B-2D2D-4A1C-84A1-CD26CB522EFC}"/>
              </a:ext>
            </a:extLst>
          </p:cNvPr>
          <p:cNvSpPr/>
          <p:nvPr/>
        </p:nvSpPr>
        <p:spPr>
          <a:xfrm>
            <a:off x="6094476" y="1199896"/>
            <a:ext cx="4347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4951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5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Figure S4. Volcano plots showing the distribution of age-associated differentially methylated CpG positions (aDMPs) with their effect size in M values and significance p value in the a) African American (AA) and b) white participants of the HANDLS study.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juddin, Salman (NIH/NIA/IRP) [F]</dc:creator>
  <cp:lastModifiedBy>Kumaraswamy Naidu Chitrala</cp:lastModifiedBy>
  <cp:revision>17</cp:revision>
  <dcterms:created xsi:type="dcterms:W3CDTF">2018-08-05T17:31:02Z</dcterms:created>
  <dcterms:modified xsi:type="dcterms:W3CDTF">2019-04-09T18:28:07Z</dcterms:modified>
</cp:coreProperties>
</file>